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24688800" cy="157067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88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086100" y="2570523"/>
            <a:ext cx="18516600" cy="5468267"/>
          </a:xfrm>
        </p:spPr>
        <p:txBody>
          <a:bodyPr anchor="b"/>
          <a:lstStyle>
            <a:lvl1pPr algn="ctr">
              <a:defRPr sz="1215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086100" y="8249668"/>
            <a:ext cx="18516600" cy="3792155"/>
          </a:xfrm>
        </p:spPr>
        <p:txBody>
          <a:bodyPr/>
          <a:lstStyle>
            <a:lvl1pPr marL="0" indent="0" algn="ctr">
              <a:buNone/>
              <a:defRPr sz="4860"/>
            </a:lvl1pPr>
            <a:lvl2pPr marL="925830" indent="0" algn="ctr">
              <a:buNone/>
              <a:defRPr sz="4050"/>
            </a:lvl2pPr>
            <a:lvl3pPr marL="1851660" indent="0" algn="ctr">
              <a:buNone/>
              <a:defRPr sz="3645"/>
            </a:lvl3pPr>
            <a:lvl4pPr marL="2777490" indent="0" algn="ctr">
              <a:buNone/>
              <a:defRPr sz="3240"/>
            </a:lvl4pPr>
            <a:lvl5pPr marL="3703320" indent="0" algn="ctr">
              <a:buNone/>
              <a:defRPr sz="3240"/>
            </a:lvl5pPr>
            <a:lvl6pPr marL="4629150" indent="0" algn="ctr">
              <a:buNone/>
              <a:defRPr sz="3240"/>
            </a:lvl6pPr>
            <a:lvl7pPr marL="5554980" indent="0" algn="ctr">
              <a:buNone/>
              <a:defRPr sz="3240"/>
            </a:lvl7pPr>
            <a:lvl8pPr marL="6480810" indent="0" algn="ctr">
              <a:buNone/>
              <a:defRPr sz="3240"/>
            </a:lvl8pPr>
            <a:lvl9pPr marL="7406640" indent="0" algn="ctr">
              <a:buNone/>
              <a:defRPr sz="324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9909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0724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7667922" y="836238"/>
            <a:ext cx="5323523" cy="133107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697355" y="836238"/>
            <a:ext cx="15661958" cy="133107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056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0843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84496" y="3915776"/>
            <a:ext cx="21294090" cy="6533560"/>
          </a:xfrm>
        </p:spPr>
        <p:txBody>
          <a:bodyPr anchor="b"/>
          <a:lstStyle>
            <a:lvl1pPr>
              <a:defRPr sz="1215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84496" y="10511146"/>
            <a:ext cx="21294090" cy="3435845"/>
          </a:xfrm>
        </p:spPr>
        <p:txBody>
          <a:bodyPr/>
          <a:lstStyle>
            <a:lvl1pPr marL="0" indent="0">
              <a:buNone/>
              <a:defRPr sz="4860">
                <a:solidFill>
                  <a:schemeClr val="tx1">
                    <a:tint val="75000"/>
                  </a:schemeClr>
                </a:solidFill>
              </a:defRPr>
            </a:lvl1pPr>
            <a:lvl2pPr marL="925830" indent="0">
              <a:buNone/>
              <a:defRPr sz="4050">
                <a:solidFill>
                  <a:schemeClr val="tx1">
                    <a:tint val="75000"/>
                  </a:schemeClr>
                </a:solidFill>
              </a:defRPr>
            </a:lvl2pPr>
            <a:lvl3pPr marL="1851660" indent="0">
              <a:buNone/>
              <a:defRPr sz="3645">
                <a:solidFill>
                  <a:schemeClr val="tx1">
                    <a:tint val="75000"/>
                  </a:schemeClr>
                </a:solidFill>
              </a:defRPr>
            </a:lvl3pPr>
            <a:lvl4pPr marL="277749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4pPr>
            <a:lvl5pPr marL="370332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5pPr>
            <a:lvl6pPr marL="462915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6pPr>
            <a:lvl7pPr marL="555498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7pPr>
            <a:lvl8pPr marL="648081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8pPr>
            <a:lvl9pPr marL="740664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1457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697355" y="4181188"/>
            <a:ext cx="10492740" cy="996577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498705" y="4181188"/>
            <a:ext cx="10492740" cy="996577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725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00571" y="836239"/>
            <a:ext cx="21294090" cy="303590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00572" y="3850330"/>
            <a:ext cx="10444519" cy="1886987"/>
          </a:xfrm>
        </p:spPr>
        <p:txBody>
          <a:bodyPr anchor="b"/>
          <a:lstStyle>
            <a:lvl1pPr marL="0" indent="0">
              <a:buNone/>
              <a:defRPr sz="4860" b="1"/>
            </a:lvl1pPr>
            <a:lvl2pPr marL="925830" indent="0">
              <a:buNone/>
              <a:defRPr sz="4050" b="1"/>
            </a:lvl2pPr>
            <a:lvl3pPr marL="1851660" indent="0">
              <a:buNone/>
              <a:defRPr sz="3645" b="1"/>
            </a:lvl3pPr>
            <a:lvl4pPr marL="2777490" indent="0">
              <a:buNone/>
              <a:defRPr sz="3240" b="1"/>
            </a:lvl4pPr>
            <a:lvl5pPr marL="3703320" indent="0">
              <a:buNone/>
              <a:defRPr sz="3240" b="1"/>
            </a:lvl5pPr>
            <a:lvl6pPr marL="4629150" indent="0">
              <a:buNone/>
              <a:defRPr sz="3240" b="1"/>
            </a:lvl6pPr>
            <a:lvl7pPr marL="5554980" indent="0">
              <a:buNone/>
              <a:defRPr sz="3240" b="1"/>
            </a:lvl7pPr>
            <a:lvl8pPr marL="6480810" indent="0">
              <a:buNone/>
              <a:defRPr sz="3240" b="1"/>
            </a:lvl8pPr>
            <a:lvl9pPr marL="7406640" indent="0">
              <a:buNone/>
              <a:defRPr sz="324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00572" y="5737318"/>
            <a:ext cx="10444519" cy="84387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498705" y="3850330"/>
            <a:ext cx="10495956" cy="1886987"/>
          </a:xfrm>
        </p:spPr>
        <p:txBody>
          <a:bodyPr anchor="b"/>
          <a:lstStyle>
            <a:lvl1pPr marL="0" indent="0">
              <a:buNone/>
              <a:defRPr sz="4860" b="1"/>
            </a:lvl1pPr>
            <a:lvl2pPr marL="925830" indent="0">
              <a:buNone/>
              <a:defRPr sz="4050" b="1"/>
            </a:lvl2pPr>
            <a:lvl3pPr marL="1851660" indent="0">
              <a:buNone/>
              <a:defRPr sz="3645" b="1"/>
            </a:lvl3pPr>
            <a:lvl4pPr marL="2777490" indent="0">
              <a:buNone/>
              <a:defRPr sz="3240" b="1"/>
            </a:lvl4pPr>
            <a:lvl5pPr marL="3703320" indent="0">
              <a:buNone/>
              <a:defRPr sz="3240" b="1"/>
            </a:lvl5pPr>
            <a:lvl6pPr marL="4629150" indent="0">
              <a:buNone/>
              <a:defRPr sz="3240" b="1"/>
            </a:lvl6pPr>
            <a:lvl7pPr marL="5554980" indent="0">
              <a:buNone/>
              <a:defRPr sz="3240" b="1"/>
            </a:lvl7pPr>
            <a:lvl8pPr marL="6480810" indent="0">
              <a:buNone/>
              <a:defRPr sz="3240" b="1"/>
            </a:lvl8pPr>
            <a:lvl9pPr marL="7406640" indent="0">
              <a:buNone/>
              <a:defRPr sz="324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498705" y="5737318"/>
            <a:ext cx="10495956" cy="84387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3645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7310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5620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00572" y="1047115"/>
            <a:ext cx="7962780" cy="3664903"/>
          </a:xfrm>
        </p:spPr>
        <p:txBody>
          <a:bodyPr anchor="b"/>
          <a:lstStyle>
            <a:lvl1pPr>
              <a:defRPr sz="648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495956" y="2261479"/>
            <a:ext cx="12498705" cy="11161955"/>
          </a:xfrm>
        </p:spPr>
        <p:txBody>
          <a:bodyPr/>
          <a:lstStyle>
            <a:lvl1pPr>
              <a:defRPr sz="6480"/>
            </a:lvl1pPr>
            <a:lvl2pPr>
              <a:defRPr sz="5670"/>
            </a:lvl2pPr>
            <a:lvl3pPr>
              <a:defRPr sz="4860"/>
            </a:lvl3pPr>
            <a:lvl4pPr>
              <a:defRPr sz="4050"/>
            </a:lvl4pPr>
            <a:lvl5pPr>
              <a:defRPr sz="4050"/>
            </a:lvl5pPr>
            <a:lvl6pPr>
              <a:defRPr sz="4050"/>
            </a:lvl6pPr>
            <a:lvl7pPr>
              <a:defRPr sz="4050"/>
            </a:lvl7pPr>
            <a:lvl8pPr>
              <a:defRPr sz="4050"/>
            </a:lvl8pPr>
            <a:lvl9pPr>
              <a:defRPr sz="405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00572" y="4712018"/>
            <a:ext cx="7962780" cy="8729595"/>
          </a:xfrm>
        </p:spPr>
        <p:txBody>
          <a:bodyPr/>
          <a:lstStyle>
            <a:lvl1pPr marL="0" indent="0">
              <a:buNone/>
              <a:defRPr sz="3240"/>
            </a:lvl1pPr>
            <a:lvl2pPr marL="925830" indent="0">
              <a:buNone/>
              <a:defRPr sz="2835"/>
            </a:lvl2pPr>
            <a:lvl3pPr marL="1851660" indent="0">
              <a:buNone/>
              <a:defRPr sz="2430"/>
            </a:lvl3pPr>
            <a:lvl4pPr marL="2777490" indent="0">
              <a:buNone/>
              <a:defRPr sz="2025"/>
            </a:lvl4pPr>
            <a:lvl5pPr marL="3703320" indent="0">
              <a:buNone/>
              <a:defRPr sz="2025"/>
            </a:lvl5pPr>
            <a:lvl6pPr marL="4629150" indent="0">
              <a:buNone/>
              <a:defRPr sz="2025"/>
            </a:lvl6pPr>
            <a:lvl7pPr marL="5554980" indent="0">
              <a:buNone/>
              <a:defRPr sz="2025"/>
            </a:lvl7pPr>
            <a:lvl8pPr marL="6480810" indent="0">
              <a:buNone/>
              <a:defRPr sz="2025"/>
            </a:lvl8pPr>
            <a:lvl9pPr marL="7406640" indent="0">
              <a:buNone/>
              <a:defRPr sz="2025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6571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00572" y="1047115"/>
            <a:ext cx="7962780" cy="3664903"/>
          </a:xfrm>
        </p:spPr>
        <p:txBody>
          <a:bodyPr anchor="b"/>
          <a:lstStyle>
            <a:lvl1pPr>
              <a:defRPr sz="648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495956" y="2261479"/>
            <a:ext cx="12498705" cy="11161955"/>
          </a:xfrm>
        </p:spPr>
        <p:txBody>
          <a:bodyPr anchor="t"/>
          <a:lstStyle>
            <a:lvl1pPr marL="0" indent="0">
              <a:buNone/>
              <a:defRPr sz="6480"/>
            </a:lvl1pPr>
            <a:lvl2pPr marL="925830" indent="0">
              <a:buNone/>
              <a:defRPr sz="5670"/>
            </a:lvl2pPr>
            <a:lvl3pPr marL="1851660" indent="0">
              <a:buNone/>
              <a:defRPr sz="4860"/>
            </a:lvl3pPr>
            <a:lvl4pPr marL="2777490" indent="0">
              <a:buNone/>
              <a:defRPr sz="4050"/>
            </a:lvl4pPr>
            <a:lvl5pPr marL="3703320" indent="0">
              <a:buNone/>
              <a:defRPr sz="4050"/>
            </a:lvl5pPr>
            <a:lvl6pPr marL="4629150" indent="0">
              <a:buNone/>
              <a:defRPr sz="4050"/>
            </a:lvl6pPr>
            <a:lvl7pPr marL="5554980" indent="0">
              <a:buNone/>
              <a:defRPr sz="4050"/>
            </a:lvl7pPr>
            <a:lvl8pPr marL="6480810" indent="0">
              <a:buNone/>
              <a:defRPr sz="4050"/>
            </a:lvl8pPr>
            <a:lvl9pPr marL="7406640" indent="0">
              <a:buNone/>
              <a:defRPr sz="405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00572" y="4712018"/>
            <a:ext cx="7962780" cy="8729595"/>
          </a:xfrm>
        </p:spPr>
        <p:txBody>
          <a:bodyPr/>
          <a:lstStyle>
            <a:lvl1pPr marL="0" indent="0">
              <a:buNone/>
              <a:defRPr sz="3240"/>
            </a:lvl1pPr>
            <a:lvl2pPr marL="925830" indent="0">
              <a:buNone/>
              <a:defRPr sz="2835"/>
            </a:lvl2pPr>
            <a:lvl3pPr marL="1851660" indent="0">
              <a:buNone/>
              <a:defRPr sz="2430"/>
            </a:lvl3pPr>
            <a:lvl4pPr marL="2777490" indent="0">
              <a:buNone/>
              <a:defRPr sz="2025"/>
            </a:lvl4pPr>
            <a:lvl5pPr marL="3703320" indent="0">
              <a:buNone/>
              <a:defRPr sz="2025"/>
            </a:lvl5pPr>
            <a:lvl6pPr marL="4629150" indent="0">
              <a:buNone/>
              <a:defRPr sz="2025"/>
            </a:lvl6pPr>
            <a:lvl7pPr marL="5554980" indent="0">
              <a:buNone/>
              <a:defRPr sz="2025"/>
            </a:lvl7pPr>
            <a:lvl8pPr marL="6480810" indent="0">
              <a:buNone/>
              <a:defRPr sz="2025"/>
            </a:lvl8pPr>
            <a:lvl9pPr marL="7406640" indent="0">
              <a:buNone/>
              <a:defRPr sz="2025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9434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697355" y="836239"/>
            <a:ext cx="21294090" cy="30359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97355" y="4181188"/>
            <a:ext cx="21294090" cy="99657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697355" y="14557808"/>
            <a:ext cx="5554980" cy="8362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2C262B-4928-4B2A-8378-D98CC99987B4}" type="datetimeFigureOut">
              <a:rPr lang="en-GB" smtClean="0"/>
              <a:t>09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178165" y="14557808"/>
            <a:ext cx="8332470" cy="8362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436465" y="14557808"/>
            <a:ext cx="5554980" cy="83623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844DD-2642-45EF-9897-48D441B171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1846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51660" rtl="0" eaLnBrk="1" latinLnBrk="0" hangingPunct="1">
        <a:lnSpc>
          <a:spcPct val="90000"/>
        </a:lnSpc>
        <a:spcBef>
          <a:spcPct val="0"/>
        </a:spcBef>
        <a:buNone/>
        <a:defRPr sz="89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62915" indent="-462915" algn="l" defTabSz="1851660" rtl="0" eaLnBrk="1" latinLnBrk="0" hangingPunct="1">
        <a:lnSpc>
          <a:spcPct val="90000"/>
        </a:lnSpc>
        <a:spcBef>
          <a:spcPts val="2025"/>
        </a:spcBef>
        <a:buFont typeface="Arial" panose="020B0604020202020204" pitchFamily="34" charset="0"/>
        <a:buChar char="•"/>
        <a:defRPr sz="5670" kern="1200">
          <a:solidFill>
            <a:schemeClr val="tx1"/>
          </a:solidFill>
          <a:latin typeface="+mn-lt"/>
          <a:ea typeface="+mn-ea"/>
          <a:cs typeface="+mn-cs"/>
        </a:defRPr>
      </a:lvl1pPr>
      <a:lvl2pPr marL="138874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4860" kern="1200">
          <a:solidFill>
            <a:schemeClr val="tx1"/>
          </a:solidFill>
          <a:latin typeface="+mn-lt"/>
          <a:ea typeface="+mn-ea"/>
          <a:cs typeface="+mn-cs"/>
        </a:defRPr>
      </a:lvl2pPr>
      <a:lvl3pPr marL="231457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4050" kern="1200">
          <a:solidFill>
            <a:schemeClr val="tx1"/>
          </a:solidFill>
          <a:latin typeface="+mn-lt"/>
          <a:ea typeface="+mn-ea"/>
          <a:cs typeface="+mn-cs"/>
        </a:defRPr>
      </a:lvl3pPr>
      <a:lvl4pPr marL="324040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3645" kern="1200">
          <a:solidFill>
            <a:schemeClr val="tx1"/>
          </a:solidFill>
          <a:latin typeface="+mn-lt"/>
          <a:ea typeface="+mn-ea"/>
          <a:cs typeface="+mn-cs"/>
        </a:defRPr>
      </a:lvl4pPr>
      <a:lvl5pPr marL="416623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3645" kern="1200">
          <a:solidFill>
            <a:schemeClr val="tx1"/>
          </a:solidFill>
          <a:latin typeface="+mn-lt"/>
          <a:ea typeface="+mn-ea"/>
          <a:cs typeface="+mn-cs"/>
        </a:defRPr>
      </a:lvl5pPr>
      <a:lvl6pPr marL="509206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3645" kern="1200">
          <a:solidFill>
            <a:schemeClr val="tx1"/>
          </a:solidFill>
          <a:latin typeface="+mn-lt"/>
          <a:ea typeface="+mn-ea"/>
          <a:cs typeface="+mn-cs"/>
        </a:defRPr>
      </a:lvl6pPr>
      <a:lvl7pPr marL="601789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3645" kern="1200">
          <a:solidFill>
            <a:schemeClr val="tx1"/>
          </a:solidFill>
          <a:latin typeface="+mn-lt"/>
          <a:ea typeface="+mn-ea"/>
          <a:cs typeface="+mn-cs"/>
        </a:defRPr>
      </a:lvl7pPr>
      <a:lvl8pPr marL="694372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3645" kern="1200">
          <a:solidFill>
            <a:schemeClr val="tx1"/>
          </a:solidFill>
          <a:latin typeface="+mn-lt"/>
          <a:ea typeface="+mn-ea"/>
          <a:cs typeface="+mn-cs"/>
        </a:defRPr>
      </a:lvl8pPr>
      <a:lvl9pPr marL="7869555" indent="-462915" algn="l" defTabSz="1851660" rtl="0" eaLnBrk="1" latinLnBrk="0" hangingPunct="1">
        <a:lnSpc>
          <a:spcPct val="90000"/>
        </a:lnSpc>
        <a:spcBef>
          <a:spcPts val="1013"/>
        </a:spcBef>
        <a:buFont typeface="Arial" panose="020B0604020202020204" pitchFamily="34" charset="0"/>
        <a:buChar char="•"/>
        <a:defRPr sz="36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1pPr>
      <a:lvl2pPr marL="92583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2pPr>
      <a:lvl3pPr marL="185166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3pPr>
      <a:lvl4pPr marL="277749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4pPr>
      <a:lvl5pPr marL="370332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5pPr>
      <a:lvl6pPr marL="462915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6pPr>
      <a:lvl7pPr marL="555498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7pPr>
      <a:lvl8pPr marL="648081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8pPr>
      <a:lvl9pPr marL="7406640" algn="l" defTabSz="1851660" rtl="0" eaLnBrk="1" latinLnBrk="0" hangingPunct="1">
        <a:defRPr sz="36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9FBEDE6C-80D4-1AC9-892A-AC395227F0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5200"/>
            <a:ext cx="8229600" cy="508406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7B087A2-9F6C-8F3B-366A-DA94DE75BB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455200"/>
            <a:ext cx="8229600" cy="5084064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96C57ECD-798B-4359-98EE-644892BFC8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455200"/>
            <a:ext cx="8229600" cy="5084064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0EF4C407-76D3-2C00-286A-47FF3DE3B3F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39931"/>
            <a:ext cx="8229600" cy="5084064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572CE925-D914-1AD6-4A65-91B4CC70486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5539931"/>
            <a:ext cx="8229600" cy="5084064"/>
          </a:xfrm>
          <a:prstGeom prst="rect">
            <a:avLst/>
          </a:prstGeom>
        </p:spPr>
      </p:pic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6FAC1EC8-28AD-0597-4ED3-988087DE9A5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9200" y="5539931"/>
            <a:ext cx="8229600" cy="5084064"/>
          </a:xfrm>
          <a:prstGeom prst="rect">
            <a:avLst/>
          </a:prstGeom>
        </p:spPr>
      </p:pic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669D1B4E-3521-3C67-DBBC-3A58974A5E4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9600" y="10622661"/>
            <a:ext cx="8229600" cy="5084064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EE291AC2-D9E5-3178-D29C-9E6511342E08}"/>
              </a:ext>
            </a:extLst>
          </p:cNvPr>
          <p:cNvSpPr/>
          <p:nvPr/>
        </p:nvSpPr>
        <p:spPr>
          <a:xfrm>
            <a:off x="0" y="0"/>
            <a:ext cx="24688800" cy="45453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b="1" dirty="0">
                <a:solidFill>
                  <a:sysClr val="windowText" lastClr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3.</a:t>
            </a:r>
            <a:r>
              <a:rPr lang="en-US" sz="2000" dirty="0">
                <a:solidFill>
                  <a:sysClr val="windowText" lastClr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umber of monthly OPD visits per 100 UCS beneficiaries from January 2017 to December 2020, stratified by age groups</a:t>
            </a:r>
            <a:endParaRPr lang="en-GB" sz="20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8250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awee Sukmanee</dc:creator>
  <cp:lastModifiedBy>Jarawee Sukmanee</cp:lastModifiedBy>
  <cp:revision>2</cp:revision>
  <dcterms:created xsi:type="dcterms:W3CDTF">2023-01-09T14:40:31Z</dcterms:created>
  <dcterms:modified xsi:type="dcterms:W3CDTF">2023-01-09T14:47:06Z</dcterms:modified>
</cp:coreProperties>
</file>